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770" r:id="rId1"/>
    <p:sldMasterId id="2147483917" r:id="rId2"/>
  </p:sldMasterIdLst>
  <p:sldIdLst>
    <p:sldId id="259" r:id="rId3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1pPr>
    <a:lvl2pPr marL="4572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2pPr>
    <a:lvl3pPr marL="9144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3pPr>
    <a:lvl4pPr marL="13716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4pPr>
    <a:lvl5pPr marL="18288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543" autoAdjust="0"/>
    <p:restoredTop sz="94673" autoAdjust="0"/>
  </p:normalViewPr>
  <p:slideViewPr>
    <p:cSldViewPr>
      <p:cViewPr>
        <p:scale>
          <a:sx n="100" d="100"/>
          <a:sy n="100" d="100"/>
        </p:scale>
        <p:origin x="1218" y="7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1.xml"/><Relationship Id="rId7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\\ris-fas1a.roslin.ed.ac.uk\taitali\PRRSV%20paper\sionagh%20microarray\RTPCR\Copy%20of%20Strat%20SHS%206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6972777712337167E-2"/>
          <c:y val="5.4028027995521546E-2"/>
          <c:w val="0.73159070787793312"/>
          <c:h val="0.93130693283472288"/>
        </c:manualLayout>
      </c:layout>
      <c:barChart>
        <c:barDir val="col"/>
        <c:grouping val="clustered"/>
        <c:varyColors val="0"/>
        <c:ser>
          <c:idx val="1"/>
          <c:order val="0"/>
          <c:tx>
            <c:strRef>
              <c:f>recap!$C$1</c:f>
              <c:strCache>
                <c:ptCount val="1"/>
                <c:pt idx="0">
                  <c:v>SLC7A9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recap!$K$2:$K$7</c:f>
                <c:numCache>
                  <c:formatCode>General</c:formatCode>
                  <c:ptCount val="6"/>
                  <c:pt idx="0">
                    <c:v>0.47231763741923066</c:v>
                  </c:pt>
                  <c:pt idx="1">
                    <c:v>0.81921823619748546</c:v>
                  </c:pt>
                  <c:pt idx="2">
                    <c:v>2.3000306459311006</c:v>
                  </c:pt>
                  <c:pt idx="3">
                    <c:v>0.42257003218255434</c:v>
                  </c:pt>
                  <c:pt idx="4">
                    <c:v>0.7979464383769882</c:v>
                  </c:pt>
                  <c:pt idx="5">
                    <c:v>1.2643341096168936</c:v>
                  </c:pt>
                </c:numCache>
              </c:numRef>
            </c:plus>
            <c:minus>
              <c:numRef>
                <c:f>recap!$K$2:$K$7</c:f>
                <c:numCache>
                  <c:formatCode>General</c:formatCode>
                  <c:ptCount val="6"/>
                  <c:pt idx="0">
                    <c:v>0.47231763741923066</c:v>
                  </c:pt>
                  <c:pt idx="1">
                    <c:v>0.81921823619748546</c:v>
                  </c:pt>
                  <c:pt idx="2">
                    <c:v>2.3000306459311006</c:v>
                  </c:pt>
                  <c:pt idx="3">
                    <c:v>0.42257003218255434</c:v>
                  </c:pt>
                  <c:pt idx="4">
                    <c:v>0.7979464383769882</c:v>
                  </c:pt>
                  <c:pt idx="5">
                    <c:v>1.2643341096168936</c:v>
                  </c:pt>
                </c:numCache>
              </c:numRef>
            </c:minus>
          </c:errBars>
          <c:cat>
            <c:numRef>
              <c:f>recap!$B$2:$B$7</c:f>
              <c:numCache>
                <c:formatCode>General</c:formatCode>
                <c:ptCount val="6"/>
              </c:numCache>
            </c:numRef>
          </c:cat>
          <c:val>
            <c:numRef>
              <c:f>recap!$C$2:$C$7</c:f>
              <c:numCache>
                <c:formatCode>General</c:formatCode>
                <c:ptCount val="6"/>
                <c:pt idx="0">
                  <c:v>-2.3844444444444406</c:v>
                </c:pt>
                <c:pt idx="1">
                  <c:v>-1.046666666666668</c:v>
                </c:pt>
                <c:pt idx="2" formatCode="0.000000">
                  <c:v>-4.2091666666666656</c:v>
                </c:pt>
                <c:pt idx="3">
                  <c:v>-2.0822222222222231</c:v>
                </c:pt>
                <c:pt idx="4">
                  <c:v>-1.4866666666666681</c:v>
                </c:pt>
                <c:pt idx="5">
                  <c:v>-1.0533333333333346</c:v>
                </c:pt>
              </c:numCache>
            </c:numRef>
          </c:val>
        </c:ser>
        <c:ser>
          <c:idx val="2"/>
          <c:order val="1"/>
          <c:tx>
            <c:strRef>
              <c:f>recap!$D$1</c:f>
              <c:strCache>
                <c:ptCount val="1"/>
                <c:pt idx="0">
                  <c:v>S100G</c:v>
                </c:pt>
              </c:strCache>
            </c:strRef>
          </c:tx>
          <c:spPr>
            <a:solidFill>
              <a:srgbClr val="00B05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recap!$L$2:$L$7</c:f>
                <c:numCache>
                  <c:formatCode>General</c:formatCode>
                  <c:ptCount val="6"/>
                  <c:pt idx="0">
                    <c:v>0.63368606161991403</c:v>
                  </c:pt>
                  <c:pt idx="1">
                    <c:v>1.3465795718077265</c:v>
                  </c:pt>
                  <c:pt idx="2">
                    <c:v>5.1333384740233958</c:v>
                  </c:pt>
                  <c:pt idx="3">
                    <c:v>2.5937803099523062</c:v>
                  </c:pt>
                  <c:pt idx="4">
                    <c:v>0.18663359495394474</c:v>
                  </c:pt>
                  <c:pt idx="5">
                    <c:v>1.6440968101020252</c:v>
                  </c:pt>
                </c:numCache>
              </c:numRef>
            </c:plus>
            <c:minus>
              <c:numRef>
                <c:f>recap!$L$2:$L$7</c:f>
                <c:numCache>
                  <c:formatCode>General</c:formatCode>
                  <c:ptCount val="6"/>
                  <c:pt idx="0">
                    <c:v>0.63368606161991403</c:v>
                  </c:pt>
                  <c:pt idx="1">
                    <c:v>1.3465795718077265</c:v>
                  </c:pt>
                  <c:pt idx="2">
                    <c:v>5.1333384740233958</c:v>
                  </c:pt>
                  <c:pt idx="3">
                    <c:v>2.5937803099523062</c:v>
                  </c:pt>
                  <c:pt idx="4">
                    <c:v>0.18663359495394474</c:v>
                  </c:pt>
                  <c:pt idx="5">
                    <c:v>1.6440968101020252</c:v>
                  </c:pt>
                </c:numCache>
              </c:numRef>
            </c:minus>
          </c:errBars>
          <c:cat>
            <c:numRef>
              <c:f>recap!$B$2:$B$7</c:f>
              <c:numCache>
                <c:formatCode>General</c:formatCode>
                <c:ptCount val="6"/>
              </c:numCache>
            </c:numRef>
          </c:cat>
          <c:val>
            <c:numRef>
              <c:f>recap!$D$2:$D$7</c:f>
              <c:numCache>
                <c:formatCode>General</c:formatCode>
                <c:ptCount val="6"/>
                <c:pt idx="0">
                  <c:v>-4.7677777777777797</c:v>
                </c:pt>
                <c:pt idx="1">
                  <c:v>-2.4066666666666698</c:v>
                </c:pt>
                <c:pt idx="2">
                  <c:v>-9.4938888888888933</c:v>
                </c:pt>
                <c:pt idx="3">
                  <c:v>-5.0200000000000031</c:v>
                </c:pt>
                <c:pt idx="4">
                  <c:v>-1.7966666666666715</c:v>
                </c:pt>
                <c:pt idx="5">
                  <c:v>-4.4566666666666697</c:v>
                </c:pt>
              </c:numCache>
            </c:numRef>
          </c:val>
        </c:ser>
        <c:ser>
          <c:idx val="3"/>
          <c:order val="2"/>
          <c:tx>
            <c:strRef>
              <c:f>recap!$E$1</c:f>
              <c:strCache>
                <c:ptCount val="1"/>
                <c:pt idx="0">
                  <c:v>SLC6A4</c:v>
                </c:pt>
              </c:strCache>
            </c:strRef>
          </c:tx>
          <c:spPr>
            <a:solidFill>
              <a:schemeClr val="accent2">
                <a:lumMod val="40000"/>
                <a:lumOff val="6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recap!$N$2:$N$7</c:f>
                <c:numCache>
                  <c:formatCode>General</c:formatCode>
                  <c:ptCount val="6"/>
                  <c:pt idx="0">
                    <c:v>0.16425664952622349</c:v>
                  </c:pt>
                  <c:pt idx="1">
                    <c:v>1.3278005576846448</c:v>
                  </c:pt>
                  <c:pt idx="2">
                    <c:v>1.9465603566861782</c:v>
                  </c:pt>
                  <c:pt idx="3">
                    <c:v>0.43330199316868179</c:v>
                  </c:pt>
                  <c:pt idx="4">
                    <c:v>0.67608349254281475</c:v>
                  </c:pt>
                  <c:pt idx="5">
                    <c:v>1.5695867192149011</c:v>
                  </c:pt>
                </c:numCache>
              </c:numRef>
            </c:plus>
            <c:minus>
              <c:numRef>
                <c:f>recap!$N$2:$N$7</c:f>
                <c:numCache>
                  <c:formatCode>General</c:formatCode>
                  <c:ptCount val="6"/>
                  <c:pt idx="0">
                    <c:v>0.16425664952622349</c:v>
                  </c:pt>
                  <c:pt idx="1">
                    <c:v>1.3278005576846448</c:v>
                  </c:pt>
                  <c:pt idx="2">
                    <c:v>1.9465603566861782</c:v>
                  </c:pt>
                  <c:pt idx="3">
                    <c:v>0.43330199316868179</c:v>
                  </c:pt>
                  <c:pt idx="4">
                    <c:v>0.67608349254281475</c:v>
                  </c:pt>
                  <c:pt idx="5">
                    <c:v>1.5695867192149011</c:v>
                  </c:pt>
                </c:numCache>
              </c:numRef>
            </c:minus>
          </c:errBars>
          <c:cat>
            <c:numRef>
              <c:f>recap!$B$2:$B$7</c:f>
              <c:numCache>
                <c:formatCode>General</c:formatCode>
                <c:ptCount val="6"/>
              </c:numCache>
            </c:numRef>
          </c:cat>
          <c:val>
            <c:numRef>
              <c:f>recap!$E$2:$E$7</c:f>
              <c:numCache>
                <c:formatCode>General</c:formatCode>
                <c:ptCount val="6"/>
                <c:pt idx="0">
                  <c:v>-3.92888888888888</c:v>
                </c:pt>
                <c:pt idx="1">
                  <c:v>-2.05277777777777</c:v>
                </c:pt>
                <c:pt idx="2">
                  <c:v>-5.2722222222222097</c:v>
                </c:pt>
                <c:pt idx="3">
                  <c:v>-3.3533333333333202</c:v>
                </c:pt>
                <c:pt idx="4">
                  <c:v>-1.4833333333333301</c:v>
                </c:pt>
                <c:pt idx="5">
                  <c:v>-2.5933333333333199</c:v>
                </c:pt>
              </c:numCache>
            </c:numRef>
          </c:val>
        </c:ser>
        <c:ser>
          <c:idx val="4"/>
          <c:order val="3"/>
          <c:tx>
            <c:strRef>
              <c:f>recap!$F$1</c:f>
              <c:strCache>
                <c:ptCount val="1"/>
                <c:pt idx="0">
                  <c:v>SLC13A1</c:v>
                </c:pt>
              </c:strCache>
            </c:strRef>
          </c:tx>
          <c:spPr>
            <a:solidFill>
              <a:srgbClr val="FFFF0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recap!$N$2:$N$7</c:f>
                <c:numCache>
                  <c:formatCode>General</c:formatCode>
                  <c:ptCount val="6"/>
                  <c:pt idx="0">
                    <c:v>0.16425664952622349</c:v>
                  </c:pt>
                  <c:pt idx="1">
                    <c:v>1.3278005576846448</c:v>
                  </c:pt>
                  <c:pt idx="2">
                    <c:v>1.9465603566861782</c:v>
                  </c:pt>
                  <c:pt idx="3">
                    <c:v>0.43330199316868179</c:v>
                  </c:pt>
                  <c:pt idx="4">
                    <c:v>0.67608349254281475</c:v>
                  </c:pt>
                  <c:pt idx="5">
                    <c:v>1.5695867192149011</c:v>
                  </c:pt>
                </c:numCache>
              </c:numRef>
            </c:plus>
            <c:minus>
              <c:numRef>
                <c:f>recap!$N$2:$N$7</c:f>
                <c:numCache>
                  <c:formatCode>General</c:formatCode>
                  <c:ptCount val="6"/>
                  <c:pt idx="0">
                    <c:v>0.16425664952622349</c:v>
                  </c:pt>
                  <c:pt idx="1">
                    <c:v>1.3278005576846448</c:v>
                  </c:pt>
                  <c:pt idx="2">
                    <c:v>1.9465603566861782</c:v>
                  </c:pt>
                  <c:pt idx="3">
                    <c:v>0.43330199316868179</c:v>
                  </c:pt>
                  <c:pt idx="4">
                    <c:v>0.67608349254281475</c:v>
                  </c:pt>
                  <c:pt idx="5">
                    <c:v>1.5695867192149011</c:v>
                  </c:pt>
                </c:numCache>
              </c:numRef>
            </c:minus>
          </c:errBars>
          <c:cat>
            <c:numRef>
              <c:f>recap!$B$2:$B$7</c:f>
              <c:numCache>
                <c:formatCode>General</c:formatCode>
                <c:ptCount val="6"/>
              </c:numCache>
            </c:numRef>
          </c:cat>
          <c:val>
            <c:numRef>
              <c:f>recap!$F$2:$F$7</c:f>
              <c:numCache>
                <c:formatCode>General</c:formatCode>
                <c:ptCount val="6"/>
                <c:pt idx="0">
                  <c:v>-2.6711111111111094</c:v>
                </c:pt>
                <c:pt idx="1">
                  <c:v>-1.098888888888889</c:v>
                </c:pt>
                <c:pt idx="2">
                  <c:v>-4.2483333333333348</c:v>
                </c:pt>
                <c:pt idx="3">
                  <c:v>-2.4777777777777779</c:v>
                </c:pt>
                <c:pt idx="4">
                  <c:v>-0.97666666666667135</c:v>
                </c:pt>
                <c:pt idx="5">
                  <c:v>-1.515555555555558</c:v>
                </c:pt>
              </c:numCache>
            </c:numRef>
          </c:val>
        </c:ser>
        <c:ser>
          <c:idx val="5"/>
          <c:order val="4"/>
          <c:tx>
            <c:strRef>
              <c:f>recap!$G$1</c:f>
              <c:strCache>
                <c:ptCount val="1"/>
                <c:pt idx="0">
                  <c:v>MUC2</c:v>
                </c:pt>
              </c:strCache>
            </c:strRef>
          </c:tx>
          <c:spPr>
            <a:solidFill>
              <a:srgbClr val="7030A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recap!$O$2:$O$7</c:f>
                <c:numCache>
                  <c:formatCode>General</c:formatCode>
                  <c:ptCount val="6"/>
                  <c:pt idx="0">
                    <c:v>0.38751184768825492</c:v>
                  </c:pt>
                  <c:pt idx="1">
                    <c:v>0.57858704009246664</c:v>
                  </c:pt>
                  <c:pt idx="2">
                    <c:v>1.3896822178709316</c:v>
                  </c:pt>
                  <c:pt idx="3">
                    <c:v>1.6927858913855816</c:v>
                  </c:pt>
                  <c:pt idx="4">
                    <c:v>0.68829903062227071</c:v>
                  </c:pt>
                  <c:pt idx="5">
                    <c:v>0.51332130818046207</c:v>
                  </c:pt>
                </c:numCache>
              </c:numRef>
            </c:plus>
            <c:minus>
              <c:numRef>
                <c:f>recap!$O$2:$O$7</c:f>
                <c:numCache>
                  <c:formatCode>General</c:formatCode>
                  <c:ptCount val="6"/>
                  <c:pt idx="0">
                    <c:v>0.38751184768825492</c:v>
                  </c:pt>
                  <c:pt idx="1">
                    <c:v>0.57858704009246664</c:v>
                  </c:pt>
                  <c:pt idx="2">
                    <c:v>1.3896822178709316</c:v>
                  </c:pt>
                  <c:pt idx="3">
                    <c:v>1.6927858913855816</c:v>
                  </c:pt>
                  <c:pt idx="4">
                    <c:v>0.68829903062227071</c:v>
                  </c:pt>
                  <c:pt idx="5">
                    <c:v>0.51332130818046207</c:v>
                  </c:pt>
                </c:numCache>
              </c:numRef>
            </c:minus>
          </c:errBars>
          <c:cat>
            <c:numRef>
              <c:f>recap!$B$2:$B$7</c:f>
              <c:numCache>
                <c:formatCode>General</c:formatCode>
                <c:ptCount val="6"/>
              </c:numCache>
            </c:numRef>
          </c:cat>
          <c:val>
            <c:numRef>
              <c:f>recap!$G$2:$G$7</c:f>
              <c:numCache>
                <c:formatCode>General</c:formatCode>
                <c:ptCount val="6"/>
                <c:pt idx="0">
                  <c:v>-1.5411111111111115</c:v>
                </c:pt>
                <c:pt idx="1">
                  <c:v>1.193333333333334</c:v>
                </c:pt>
                <c:pt idx="2">
                  <c:v>-4.2366666666666699</c:v>
                </c:pt>
                <c:pt idx="3">
                  <c:v>-2.4350000000000023</c:v>
                </c:pt>
                <c:pt idx="4">
                  <c:v>-3.3533333333333366</c:v>
                </c:pt>
                <c:pt idx="5">
                  <c:v>1.7988888888888883</c:v>
                </c:pt>
              </c:numCache>
            </c:numRef>
          </c:val>
        </c:ser>
        <c:ser>
          <c:idx val="6"/>
          <c:order val="5"/>
          <c:tx>
            <c:strRef>
              <c:f>recap!$H$1</c:f>
              <c:strCache>
                <c:ptCount val="1"/>
                <c:pt idx="0">
                  <c:v> TGFBR1</c:v>
                </c:pt>
              </c:strCache>
            </c:strRef>
          </c:tx>
          <c:spPr>
            <a:solidFill>
              <a:srgbClr val="00B0F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recap!$P$2:$P$7</c:f>
                <c:numCache>
                  <c:formatCode>General</c:formatCode>
                  <c:ptCount val="6"/>
                  <c:pt idx="0">
                    <c:v>0.41333632018036748</c:v>
                  </c:pt>
                  <c:pt idx="1">
                    <c:v>0.88054525444767406</c:v>
                  </c:pt>
                  <c:pt idx="2">
                    <c:v>0.31213954520216269</c:v>
                  </c:pt>
                  <c:pt idx="3">
                    <c:v>0.17591695883579822</c:v>
                  </c:pt>
                  <c:pt idx="4">
                    <c:v>0.30314809158578349</c:v>
                  </c:pt>
                  <c:pt idx="5">
                    <c:v>0.49995665107011444</c:v>
                  </c:pt>
                </c:numCache>
              </c:numRef>
            </c:plus>
            <c:minus>
              <c:numRef>
                <c:f>recap!$P$2:$P$7</c:f>
                <c:numCache>
                  <c:formatCode>General</c:formatCode>
                  <c:ptCount val="6"/>
                  <c:pt idx="0">
                    <c:v>0.41333632018036748</c:v>
                  </c:pt>
                  <c:pt idx="1">
                    <c:v>0.88054525444767406</c:v>
                  </c:pt>
                  <c:pt idx="2">
                    <c:v>0.31213954520216269</c:v>
                  </c:pt>
                  <c:pt idx="3">
                    <c:v>0.17591695883579822</c:v>
                  </c:pt>
                  <c:pt idx="4">
                    <c:v>0.30314809158578349</c:v>
                  </c:pt>
                  <c:pt idx="5">
                    <c:v>0.49995665107011444</c:v>
                  </c:pt>
                </c:numCache>
              </c:numRef>
            </c:minus>
          </c:errBars>
          <c:cat>
            <c:numRef>
              <c:f>recap!$B$2:$B$7</c:f>
              <c:numCache>
                <c:formatCode>General</c:formatCode>
                <c:ptCount val="6"/>
              </c:numCache>
            </c:numRef>
          </c:cat>
          <c:val>
            <c:numRef>
              <c:f>recap!$H$2:$H$7</c:f>
              <c:numCache>
                <c:formatCode>General</c:formatCode>
                <c:ptCount val="6"/>
                <c:pt idx="0">
                  <c:v>-1.8833333333333329</c:v>
                </c:pt>
                <c:pt idx="1">
                  <c:v>-1.1207407407407384</c:v>
                </c:pt>
                <c:pt idx="2">
                  <c:v>1.144166666666667</c:v>
                </c:pt>
                <c:pt idx="3">
                  <c:v>0.39703703703703624</c:v>
                </c:pt>
                <c:pt idx="4">
                  <c:v>1.0522222222222162</c:v>
                </c:pt>
                <c:pt idx="5">
                  <c:v>0.93037037037037129</c:v>
                </c:pt>
              </c:numCache>
            </c:numRef>
          </c:val>
        </c:ser>
        <c:ser>
          <c:idx val="7"/>
          <c:order val="6"/>
          <c:tx>
            <c:strRef>
              <c:f>recap!$I$1</c:f>
              <c:strCache>
                <c:ptCount val="1"/>
                <c:pt idx="0">
                  <c:v>CD163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recap!$Q$2:$Q$7</c:f>
                <c:numCache>
                  <c:formatCode>General</c:formatCode>
                  <c:ptCount val="6"/>
                  <c:pt idx="0">
                    <c:v>0.2661991787055028</c:v>
                  </c:pt>
                  <c:pt idx="1">
                    <c:v>1.4634341482187849</c:v>
                  </c:pt>
                  <c:pt idx="2">
                    <c:v>1.9798602293540279</c:v>
                  </c:pt>
                  <c:pt idx="3">
                    <c:v>1.3127419236181519</c:v>
                  </c:pt>
                  <c:pt idx="4">
                    <c:v>1.1286646758968253</c:v>
                  </c:pt>
                  <c:pt idx="5">
                    <c:v>1.1872855231915549</c:v>
                  </c:pt>
                </c:numCache>
              </c:numRef>
            </c:plus>
            <c:minus>
              <c:numRef>
                <c:f>recap!$Q$2:$Q$7</c:f>
                <c:numCache>
                  <c:formatCode>General</c:formatCode>
                  <c:ptCount val="6"/>
                  <c:pt idx="0">
                    <c:v>0.2661991787055028</c:v>
                  </c:pt>
                  <c:pt idx="1">
                    <c:v>1.4634341482187849</c:v>
                  </c:pt>
                  <c:pt idx="2">
                    <c:v>1.9798602293540279</c:v>
                  </c:pt>
                  <c:pt idx="3">
                    <c:v>1.3127419236181519</c:v>
                  </c:pt>
                  <c:pt idx="4">
                    <c:v>1.1286646758968253</c:v>
                  </c:pt>
                  <c:pt idx="5">
                    <c:v>1.1872855231915549</c:v>
                  </c:pt>
                </c:numCache>
              </c:numRef>
            </c:minus>
          </c:errBars>
          <c:cat>
            <c:numRef>
              <c:f>recap!$B$2:$B$7</c:f>
              <c:numCache>
                <c:formatCode>General</c:formatCode>
                <c:ptCount val="6"/>
              </c:numCache>
            </c:numRef>
          </c:cat>
          <c:val>
            <c:numRef>
              <c:f>recap!$I$2:$I$7</c:f>
              <c:numCache>
                <c:formatCode>General</c:formatCode>
                <c:ptCount val="6"/>
                <c:pt idx="0">
                  <c:v>0.12888888888888891</c:v>
                </c:pt>
                <c:pt idx="1">
                  <c:v>1.2222222222222203</c:v>
                </c:pt>
                <c:pt idx="2">
                  <c:v>2.258611111111108</c:v>
                </c:pt>
                <c:pt idx="3">
                  <c:v>1.0955555555555527</c:v>
                </c:pt>
                <c:pt idx="4">
                  <c:v>1.093333333333329</c:v>
                </c:pt>
                <c:pt idx="5">
                  <c:v>1.197777777777774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49509040"/>
        <c:axId val="153808400"/>
      </c:barChart>
      <c:catAx>
        <c:axId val="2495090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53808400"/>
        <c:crosses val="autoZero"/>
        <c:auto val="1"/>
        <c:lblAlgn val="ctr"/>
        <c:lblOffset val="100"/>
        <c:noMultiLvlLbl val="0"/>
      </c:catAx>
      <c:valAx>
        <c:axId val="153808400"/>
        <c:scaling>
          <c:orientation val="minMax"/>
          <c:max val="5"/>
          <c:min val="-10"/>
        </c:scaling>
        <c:delete val="0"/>
        <c:axPos val="l"/>
        <c:numFmt formatCode="General" sourceLinked="1"/>
        <c:majorTickMark val="out"/>
        <c:minorTickMark val="none"/>
        <c:tickLblPos val="nextTo"/>
        <c:crossAx val="249509040"/>
        <c:crosses val="autoZero"/>
        <c:crossBetween val="between"/>
        <c:majorUnit val="2"/>
        <c:minorUnit val="1"/>
      </c:valAx>
      <c:spPr>
        <a:noFill/>
        <a:ln w="25400">
          <a:noFill/>
        </a:ln>
      </c:spPr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8751</cdr:x>
      <cdr:y>0.03828</cdr:y>
    </cdr:from>
    <cdr:to>
      <cdr:x>0.13109</cdr:x>
      <cdr:y>0.09744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526811" y="184666"/>
          <a:ext cx="262379" cy="28543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GB" sz="1600" b="1" dirty="0" smtClean="0">
              <a:solidFill>
                <a:schemeClr val="tx1"/>
              </a:solidFill>
            </a:rPr>
            <a:t>3</a:t>
          </a:r>
          <a:endParaRPr lang="en-GB" sz="1600" b="1" dirty="0">
            <a:solidFill>
              <a:schemeClr val="tx1"/>
            </a:solidFill>
          </a:endParaRPr>
        </a:p>
      </cdr:txBody>
    </cdr:sp>
  </cdr:relSizeAnchor>
  <cdr:relSizeAnchor xmlns:cdr="http://schemas.openxmlformats.org/drawingml/2006/chartDrawing">
    <cdr:from>
      <cdr:x>0.20696</cdr:x>
      <cdr:y>0.03828</cdr:y>
    </cdr:from>
    <cdr:to>
      <cdr:x>0.25054</cdr:x>
      <cdr:y>0.09744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1245898" y="184666"/>
          <a:ext cx="262379" cy="28543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GB" sz="1600" b="1" dirty="0" smtClean="0">
              <a:solidFill>
                <a:schemeClr val="tx1"/>
              </a:solidFill>
            </a:rPr>
            <a:t>7</a:t>
          </a:r>
          <a:endParaRPr lang="en-GB" sz="1600" b="1" dirty="0">
            <a:solidFill>
              <a:schemeClr val="tx1"/>
            </a:solidFill>
          </a:endParaRPr>
        </a:p>
      </cdr:txBody>
    </cdr:sp>
  </cdr:relSizeAnchor>
  <cdr:relSizeAnchor xmlns:cdr="http://schemas.openxmlformats.org/drawingml/2006/chartDrawing">
    <cdr:from>
      <cdr:x>0.3264</cdr:x>
      <cdr:y>0.03828</cdr:y>
    </cdr:from>
    <cdr:to>
      <cdr:x>0.36999</cdr:x>
      <cdr:y>0.09744</cdr:y>
    </cdr:to>
    <cdr:sp macro="" textlink="">
      <cdr:nvSpPr>
        <cdr:cNvPr id="4" name="TextBox 3"/>
        <cdr:cNvSpPr txBox="1"/>
      </cdr:nvSpPr>
      <cdr:spPr>
        <a:xfrm xmlns:a="http://schemas.openxmlformats.org/drawingml/2006/main">
          <a:off x="1964985" y="184666"/>
          <a:ext cx="262379" cy="28543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GB" sz="1600" b="1" dirty="0" smtClean="0">
              <a:solidFill>
                <a:schemeClr val="tx1"/>
              </a:solidFill>
            </a:rPr>
            <a:t>14</a:t>
          </a:r>
          <a:endParaRPr lang="en-GB" sz="1600" b="1" dirty="0">
            <a:solidFill>
              <a:schemeClr val="tx1"/>
            </a:solidFill>
          </a:endParaRPr>
        </a:p>
      </cdr:txBody>
    </cdr:sp>
  </cdr:relSizeAnchor>
  <cdr:relSizeAnchor xmlns:cdr="http://schemas.openxmlformats.org/drawingml/2006/chartDrawing">
    <cdr:from>
      <cdr:x>0.44585</cdr:x>
      <cdr:y>0.03828</cdr:y>
    </cdr:from>
    <cdr:to>
      <cdr:x>0.48943</cdr:x>
      <cdr:y>0.09744</cdr:y>
    </cdr:to>
    <cdr:sp macro="" textlink="">
      <cdr:nvSpPr>
        <cdr:cNvPr id="5" name="TextBox 4"/>
        <cdr:cNvSpPr txBox="1"/>
      </cdr:nvSpPr>
      <cdr:spPr>
        <a:xfrm xmlns:a="http://schemas.openxmlformats.org/drawingml/2006/main">
          <a:off x="2684072" y="184666"/>
          <a:ext cx="262379" cy="28543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GB" sz="1600" b="1" dirty="0" smtClean="0">
              <a:solidFill>
                <a:schemeClr val="tx1"/>
              </a:solidFill>
            </a:rPr>
            <a:t>21</a:t>
          </a:r>
          <a:endParaRPr lang="en-GB" sz="1600" b="1" dirty="0">
            <a:solidFill>
              <a:schemeClr val="tx1"/>
            </a:solidFill>
          </a:endParaRPr>
        </a:p>
      </cdr:txBody>
    </cdr:sp>
  </cdr:relSizeAnchor>
  <cdr:relSizeAnchor xmlns:cdr="http://schemas.openxmlformats.org/drawingml/2006/chartDrawing">
    <cdr:from>
      <cdr:x>0.5653</cdr:x>
      <cdr:y>0.03828</cdr:y>
    </cdr:from>
    <cdr:to>
      <cdr:x>0.60888</cdr:x>
      <cdr:y>0.09744</cdr:y>
    </cdr:to>
    <cdr:sp macro="" textlink="">
      <cdr:nvSpPr>
        <cdr:cNvPr id="6" name="TextBox 5"/>
        <cdr:cNvSpPr txBox="1"/>
      </cdr:nvSpPr>
      <cdr:spPr>
        <a:xfrm xmlns:a="http://schemas.openxmlformats.org/drawingml/2006/main">
          <a:off x="3403159" y="184666"/>
          <a:ext cx="262379" cy="28543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GB" sz="1600" b="1" dirty="0" smtClean="0">
              <a:solidFill>
                <a:schemeClr val="tx1"/>
              </a:solidFill>
            </a:rPr>
            <a:t>28</a:t>
          </a:r>
          <a:endParaRPr lang="en-GB" sz="1600" b="1" dirty="0">
            <a:solidFill>
              <a:schemeClr val="tx1"/>
            </a:solidFill>
          </a:endParaRPr>
        </a:p>
      </cdr:txBody>
    </cdr:sp>
  </cdr:relSizeAnchor>
  <cdr:relSizeAnchor xmlns:cdr="http://schemas.openxmlformats.org/drawingml/2006/chartDrawing">
    <cdr:from>
      <cdr:x>0.68475</cdr:x>
      <cdr:y>0.03828</cdr:y>
    </cdr:from>
    <cdr:to>
      <cdr:x>0.72833</cdr:x>
      <cdr:y>0.09744</cdr:y>
    </cdr:to>
    <cdr:sp macro="" textlink="">
      <cdr:nvSpPr>
        <cdr:cNvPr id="7" name="TextBox 6"/>
        <cdr:cNvSpPr txBox="1"/>
      </cdr:nvSpPr>
      <cdr:spPr>
        <a:xfrm xmlns:a="http://schemas.openxmlformats.org/drawingml/2006/main">
          <a:off x="4122246" y="184666"/>
          <a:ext cx="262379" cy="28543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GB" sz="1600" b="1" dirty="0" smtClean="0">
              <a:solidFill>
                <a:schemeClr val="tx1"/>
              </a:solidFill>
            </a:rPr>
            <a:t>35</a:t>
          </a:r>
          <a:endParaRPr lang="en-GB" sz="1600" b="1" dirty="0">
            <a:solidFill>
              <a:schemeClr val="tx1"/>
            </a:solidFill>
          </a:endParaRPr>
        </a:p>
      </cdr:txBody>
    </cdr:sp>
  </cdr:relSizeAnchor>
  <cdr:relSizeAnchor xmlns:cdr="http://schemas.openxmlformats.org/drawingml/2006/chartDrawing">
    <cdr:from>
      <cdr:x>0.80259</cdr:x>
      <cdr:y>0.04767</cdr:y>
    </cdr:from>
    <cdr:to>
      <cdr:x>0.99823</cdr:x>
      <cdr:y>0.10544</cdr:y>
    </cdr:to>
    <cdr:sp macro="" textlink="">
      <cdr:nvSpPr>
        <cdr:cNvPr id="8" name="TextBox 7"/>
        <cdr:cNvSpPr txBox="1"/>
      </cdr:nvSpPr>
      <cdr:spPr>
        <a:xfrm xmlns:a="http://schemas.openxmlformats.org/drawingml/2006/main">
          <a:off x="5562406" y="229962"/>
          <a:ext cx="1355903" cy="27874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GB" sz="1100" b="1" dirty="0" smtClean="0"/>
            <a:t>days post challenge</a:t>
          </a:r>
          <a:endParaRPr lang="en-GB" sz="1100" b="1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bg>
      <p:bgPr>
        <a:blipFill dpi="0" rotWithShape="1">
          <a:blip r:embed="rId2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 anchor="ctr">
            <a:noAutofit/>
          </a:bodyPr>
          <a:lstStyle>
            <a:lvl1pPr algn="ctr">
              <a:defRPr>
                <a:solidFill>
                  <a:schemeClr val="accent1">
                    <a:lumMod val="60000"/>
                    <a:lumOff val="40000"/>
                  </a:schemeClr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accent4">
                    <a:lumMod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2752815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334A2-9374-4430-B906-FB794814E035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7/04/2014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15588-27E7-40F7-91A1-9686ECC9B121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932711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334A2-9374-4430-B906-FB794814E035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7/04/2014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15588-27E7-40F7-91A1-9686ECC9B121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30658409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334A2-9374-4430-B906-FB794814E035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7/04/2014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15588-27E7-40F7-91A1-9686ECC9B121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87520848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334A2-9374-4430-B906-FB794814E035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7/04/2014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15588-27E7-40F7-91A1-9686ECC9B121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02889428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334A2-9374-4430-B906-FB794814E035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7/04/2014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15588-27E7-40F7-91A1-9686ECC9B121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73122373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334A2-9374-4430-B906-FB794814E035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7/04/2014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15588-27E7-40F7-91A1-9686ECC9B121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75102842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334A2-9374-4430-B906-FB794814E035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7/04/2014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15588-27E7-40F7-91A1-9686ECC9B121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60090522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334A2-9374-4430-B906-FB794814E035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7/04/2014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15588-27E7-40F7-91A1-9686ECC9B121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5559057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334A2-9374-4430-B906-FB794814E035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7/04/2014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15588-27E7-40F7-91A1-9686ECC9B121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879257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solidFill>
                  <a:schemeClr val="accent1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0038F6-5ABA-E34B-ACD9-3A56EC1E1DC3}" type="datetime1">
              <a:rPr lang="en-US"/>
              <a:pPr>
                <a:defRPr/>
              </a:pPr>
              <a:t>4/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8EF4314-E115-4541-9702-0FD496A07D43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7348954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143000"/>
            <a:ext cx="4038600" cy="49831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143000"/>
            <a:ext cx="4038600" cy="49831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7CF255-F9C0-3E4E-A3B0-91189C832E6B}" type="datetime1">
              <a:rPr lang="en-US"/>
              <a:pPr>
                <a:defRPr/>
              </a:pPr>
              <a:t>4/7/2014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771BE5A-A983-314C-8ED4-9AE417782947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994624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143000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1828800"/>
            <a:ext cx="4040188" cy="4297363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143000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1828800"/>
            <a:ext cx="4041775" cy="4297363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CECAE7E-8EFB-1245-BE22-25B645EB9D72}" type="datetime1">
              <a:rPr lang="en-US"/>
              <a:pPr>
                <a:defRPr/>
              </a:pPr>
              <a:t>4/7/2014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DA595A-9216-E343-AEDF-21F5495D155D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3853199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8E852E4-D416-4A4D-AAB6-D91271A032FC}" type="datetime1">
              <a:rPr lang="en-US"/>
              <a:pPr>
                <a:defRPr/>
              </a:pPr>
              <a:t>4/7/2014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D25B1BF-4126-464B-BDA0-561947856275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9715031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93A5E9-3E5C-904E-B9F4-15870439CD17}" type="datetime1">
              <a:rPr lang="en-US"/>
              <a:pPr>
                <a:defRPr/>
              </a:pPr>
              <a:t>4/7/2014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93987B2-AE62-F44C-BE01-1608B032CE12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097362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1219200"/>
            <a:ext cx="8229600" cy="490696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B971924-B330-C648-9B8B-43862660211D}" type="datetime1">
              <a:rPr lang="en-US"/>
              <a:pPr>
                <a:defRPr/>
              </a:pPr>
              <a:t>4/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FE96353-74CF-B74B-B18B-23E1CF9EA9DB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9200567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334A2-9374-4430-B906-FB794814E035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7/04/2014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15588-27E7-40F7-91A1-9686ECC9B121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280268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334A2-9374-4430-B906-FB794814E035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7/04/2014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15588-27E7-40F7-91A1-9686ECC9B121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559597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9" Type="http://schemas.openxmlformats.org/officeDocument/2006/relationships/image" Target="../media/image1.jpg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5.xml"/><Relationship Id="rId3" Type="http://schemas.openxmlformats.org/officeDocument/2006/relationships/slideLayout" Target="../slideLayouts/slideLayout10.xml"/><Relationship Id="rId7" Type="http://schemas.openxmlformats.org/officeDocument/2006/relationships/slideLayout" Target="../slideLayouts/slideLayout14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9.xml"/><Relationship Id="rId1" Type="http://schemas.openxmlformats.org/officeDocument/2006/relationships/slideLayout" Target="../slideLayouts/slideLayout8.xml"/><Relationship Id="rId6" Type="http://schemas.openxmlformats.org/officeDocument/2006/relationships/slideLayout" Target="../slideLayouts/slideLayout13.xml"/><Relationship Id="rId11" Type="http://schemas.openxmlformats.org/officeDocument/2006/relationships/slideLayout" Target="../slideLayouts/slideLayout18.xml"/><Relationship Id="rId5" Type="http://schemas.openxmlformats.org/officeDocument/2006/relationships/slideLayout" Target="../slideLayouts/slideLayout12.xml"/><Relationship Id="rId10" Type="http://schemas.openxmlformats.org/officeDocument/2006/relationships/slideLayout" Target="../slideLayouts/slideLayout17.xml"/><Relationship Id="rId4" Type="http://schemas.openxmlformats.org/officeDocument/2006/relationships/slideLayout" Target="../slideLayouts/slideLayout11.xml"/><Relationship Id="rId9" Type="http://schemas.openxmlformats.org/officeDocument/2006/relationships/slideLayout" Target="../slideLayouts/slideLayout16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9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76200" y="152400"/>
            <a:ext cx="5715000" cy="646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  <a:spAutoFit/>
          </a:bodyPr>
          <a:lstStyle/>
          <a:p>
            <a:pPr lvl="0"/>
            <a:r>
              <a:rPr lang="en-US"/>
              <a:t>Click to edit Master tit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143000"/>
            <a:ext cx="8229600" cy="49831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0" hangingPunct="0">
              <a:defRPr sz="1200" smtClean="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FC16CF0D-7B0C-5C4D-9CCD-D300DE320234}" type="datetime1">
              <a:rPr lang="en-US"/>
              <a:pPr>
                <a:defRPr/>
              </a:pPr>
              <a:t>4/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0" hangingPunct="0">
              <a:defRPr sz="1200">
                <a:solidFill>
                  <a:schemeClr val="tx1">
                    <a:tint val="75000"/>
                  </a:schemeClr>
                </a:solidFill>
                <a:ea typeface="ＭＳ Ｐゴシック" charset="-128"/>
                <a:cs typeface="ＭＳ Ｐゴシック" charset="-128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0" hangingPunct="0">
              <a:defRPr sz="1200" smtClean="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A78F22A-28D6-A149-935A-0331A5F12D7C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916" r:id="rId1"/>
    <p:sldLayoutId id="2147483900" r:id="rId2"/>
    <p:sldLayoutId id="2147483901" r:id="rId3"/>
    <p:sldLayoutId id="2147483902" r:id="rId4"/>
    <p:sldLayoutId id="2147483903" r:id="rId5"/>
    <p:sldLayoutId id="2147483904" r:id="rId6"/>
    <p:sldLayoutId id="2147483905" r:id="rId7"/>
  </p:sldLayoutIdLst>
  <p:timing>
    <p:tnLst>
      <p:par>
        <p:cTn id="1" dur="indefinite" restart="never" nodeType="tmRoot"/>
      </p:par>
    </p:tnLst>
  </p:timing>
  <p:txStyles>
    <p:titleStyle>
      <a:lvl1pPr algn="l" defTabSz="457200" rtl="0" eaLnBrk="1" fontAlgn="base" hangingPunct="1">
        <a:spcBef>
          <a:spcPct val="0"/>
        </a:spcBef>
        <a:spcAft>
          <a:spcPct val="0"/>
        </a:spcAft>
        <a:defRPr sz="3600" kern="1200">
          <a:solidFill>
            <a:schemeClr val="accent1"/>
          </a:solidFill>
          <a:latin typeface="+mj-lt"/>
          <a:ea typeface="ＭＳ Ｐゴシック" charset="-128"/>
          <a:cs typeface="ＭＳ Ｐゴシック" charset="-128"/>
        </a:defRPr>
      </a:lvl1pPr>
      <a:lvl2pPr algn="l" defTabSz="457200" rtl="0" eaLnBrk="1" fontAlgn="base" hangingPunct="1">
        <a:spcBef>
          <a:spcPct val="0"/>
        </a:spcBef>
        <a:spcAft>
          <a:spcPct val="0"/>
        </a:spcAft>
        <a:defRPr sz="3600">
          <a:solidFill>
            <a:schemeClr val="accent1"/>
          </a:solidFill>
          <a:latin typeface="Calibri" charset="0"/>
          <a:ea typeface="ＭＳ Ｐゴシック" charset="-128"/>
          <a:cs typeface="ＭＳ Ｐゴシック" charset="-128"/>
        </a:defRPr>
      </a:lvl2pPr>
      <a:lvl3pPr algn="l" defTabSz="457200" rtl="0" eaLnBrk="1" fontAlgn="base" hangingPunct="1">
        <a:spcBef>
          <a:spcPct val="0"/>
        </a:spcBef>
        <a:spcAft>
          <a:spcPct val="0"/>
        </a:spcAft>
        <a:defRPr sz="3600">
          <a:solidFill>
            <a:schemeClr val="accent1"/>
          </a:solidFill>
          <a:latin typeface="Calibri" charset="0"/>
          <a:ea typeface="ＭＳ Ｐゴシック" charset="-128"/>
          <a:cs typeface="ＭＳ Ｐゴシック" charset="-128"/>
        </a:defRPr>
      </a:lvl3pPr>
      <a:lvl4pPr algn="l" defTabSz="457200" rtl="0" eaLnBrk="1" fontAlgn="base" hangingPunct="1">
        <a:spcBef>
          <a:spcPct val="0"/>
        </a:spcBef>
        <a:spcAft>
          <a:spcPct val="0"/>
        </a:spcAft>
        <a:defRPr sz="3600">
          <a:solidFill>
            <a:schemeClr val="accent1"/>
          </a:solidFill>
          <a:latin typeface="Calibri" charset="0"/>
          <a:ea typeface="ＭＳ Ｐゴシック" charset="-128"/>
          <a:cs typeface="ＭＳ Ｐゴシック" charset="-128"/>
        </a:defRPr>
      </a:lvl4pPr>
      <a:lvl5pPr algn="l" defTabSz="457200" rtl="0" eaLnBrk="1" fontAlgn="base" hangingPunct="1">
        <a:spcBef>
          <a:spcPct val="0"/>
        </a:spcBef>
        <a:spcAft>
          <a:spcPct val="0"/>
        </a:spcAft>
        <a:defRPr sz="3600">
          <a:solidFill>
            <a:schemeClr val="accent1"/>
          </a:solidFill>
          <a:latin typeface="Calibri" charset="0"/>
          <a:ea typeface="ＭＳ Ｐゴシック" charset="-128"/>
          <a:cs typeface="ＭＳ Ｐゴシック" charset="-128"/>
        </a:defRPr>
      </a:lvl5pPr>
      <a:lvl6pPr marL="457200" algn="ctr" defTabSz="457200" rtl="0" eaLnBrk="1" fontAlgn="base" hangingPunct="1">
        <a:spcBef>
          <a:spcPct val="0"/>
        </a:spcBef>
        <a:spcAft>
          <a:spcPct val="0"/>
        </a:spcAft>
        <a:defRPr sz="3600">
          <a:solidFill>
            <a:srgbClr val="E8DF36"/>
          </a:solidFill>
          <a:latin typeface="Calibri" charset="0"/>
          <a:ea typeface="ＭＳ Ｐゴシック" charset="-128"/>
          <a:cs typeface="ＭＳ Ｐゴシック" charset="-128"/>
        </a:defRPr>
      </a:lvl6pPr>
      <a:lvl7pPr marL="914400" algn="ctr" defTabSz="457200" rtl="0" eaLnBrk="1" fontAlgn="base" hangingPunct="1">
        <a:spcBef>
          <a:spcPct val="0"/>
        </a:spcBef>
        <a:spcAft>
          <a:spcPct val="0"/>
        </a:spcAft>
        <a:defRPr sz="3600">
          <a:solidFill>
            <a:srgbClr val="E8DF36"/>
          </a:solidFill>
          <a:latin typeface="Calibri" charset="0"/>
          <a:ea typeface="ＭＳ Ｐゴシック" charset="-128"/>
          <a:cs typeface="ＭＳ Ｐゴシック" charset="-128"/>
        </a:defRPr>
      </a:lvl7pPr>
      <a:lvl8pPr marL="1371600" algn="ctr" defTabSz="457200" rtl="0" eaLnBrk="1" fontAlgn="base" hangingPunct="1">
        <a:spcBef>
          <a:spcPct val="0"/>
        </a:spcBef>
        <a:spcAft>
          <a:spcPct val="0"/>
        </a:spcAft>
        <a:defRPr sz="3600">
          <a:solidFill>
            <a:srgbClr val="E8DF36"/>
          </a:solidFill>
          <a:latin typeface="Calibri" charset="0"/>
          <a:ea typeface="ＭＳ Ｐゴシック" charset="-128"/>
          <a:cs typeface="ＭＳ Ｐゴシック" charset="-128"/>
        </a:defRPr>
      </a:lvl8pPr>
      <a:lvl9pPr marL="1828800" algn="ctr" defTabSz="457200" rtl="0" eaLnBrk="1" fontAlgn="base" hangingPunct="1">
        <a:spcBef>
          <a:spcPct val="0"/>
        </a:spcBef>
        <a:spcAft>
          <a:spcPct val="0"/>
        </a:spcAft>
        <a:defRPr sz="3600">
          <a:solidFill>
            <a:srgbClr val="E8DF36"/>
          </a:solidFill>
          <a:latin typeface="Calibri" charset="0"/>
          <a:ea typeface="ＭＳ Ｐゴシック" charset="-128"/>
          <a:cs typeface="ＭＳ Ｐゴシック" charset="-128"/>
        </a:defRPr>
      </a:lvl9pPr>
    </p:titleStyle>
    <p:bodyStyle>
      <a:lvl1pPr marL="342900" indent="-342900" algn="l" defTabSz="457200" rtl="0" eaLnBrk="1" fontAlgn="base" hangingPunct="1">
        <a:spcBef>
          <a:spcPts val="15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ＭＳ Ｐゴシック" charset="-128"/>
          <a:cs typeface="ＭＳ Ｐゴシック" charset="-128"/>
        </a:defRPr>
      </a:lvl1pPr>
      <a:lvl2pPr marL="742950" indent="-28575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ＭＳ Ｐゴシック" charset="-128"/>
          <a:cs typeface="+mn-cs"/>
        </a:defRPr>
      </a:lvl2pPr>
      <a:lvl3pPr marL="11430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ＭＳ Ｐゴシック" charset="-128"/>
          <a:cs typeface="+mn-cs"/>
        </a:defRPr>
      </a:lvl3pPr>
      <a:lvl4pPr marL="16002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ＭＳ Ｐゴシック" charset="-128"/>
          <a:cs typeface="+mn-cs"/>
        </a:defRPr>
      </a:lvl4pPr>
      <a:lvl5pPr marL="20574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ＭＳ Ｐゴシック" charset="-128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BDC334A2-9374-4430-B906-FB794814E035}" type="datetimeFigureOut">
              <a:rPr lang="en-GB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07/04/2014</a:t>
            </a:fld>
            <a:endParaRPr lang="en-GB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endParaRPr lang="en-GB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CED15588-27E7-40F7-91A1-9686ECC9B121}" type="slidenum">
              <a:rPr lang="en-GB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N°›</a:t>
            </a:fld>
            <a:endParaRPr lang="en-GB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40990659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918" r:id="rId1"/>
    <p:sldLayoutId id="2147483919" r:id="rId2"/>
    <p:sldLayoutId id="2147483920" r:id="rId3"/>
    <p:sldLayoutId id="2147483921" r:id="rId4"/>
    <p:sldLayoutId id="2147483922" r:id="rId5"/>
    <p:sldLayoutId id="2147483923" r:id="rId6"/>
    <p:sldLayoutId id="2147483924" r:id="rId7"/>
    <p:sldLayoutId id="2147483925" r:id="rId8"/>
    <p:sldLayoutId id="2147483926" r:id="rId9"/>
    <p:sldLayoutId id="2147483927" r:id="rId10"/>
    <p:sldLayoutId id="2147483928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3203848" y="476672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endParaRPr lang="en-GB" sz="1800" dirty="0">
              <a:solidFill>
                <a:prstClr val="black"/>
              </a:solidFill>
              <a:latin typeface="Calibri"/>
            </a:endParaRPr>
          </a:p>
        </p:txBody>
      </p:sp>
      <p:sp>
        <p:nvSpPr>
          <p:cNvPr id="4" name="Text Box 4344"/>
          <p:cNvSpPr txBox="1">
            <a:spLocks noChangeArrowheads="1"/>
          </p:cNvSpPr>
          <p:nvPr/>
        </p:nvSpPr>
        <p:spPr bwMode="auto">
          <a:xfrm rot="16200000">
            <a:off x="-556886" y="2538758"/>
            <a:ext cx="4150495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lang="en-GB" altLang="en-US" sz="1000" dirty="0" smtClean="0">
                <a:solidFill>
                  <a:prstClr val="black"/>
                </a:solidFill>
              </a:rPr>
              <a:t>fold regulation of transcript normalized over  the untreated control and </a:t>
            </a:r>
            <a:endParaRPr lang="en-GB" altLang="en-US" sz="1000" dirty="0">
              <a:solidFill>
                <a:prstClr val="black"/>
              </a:solidFill>
            </a:endParaRPr>
          </a:p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lang="en-GB" altLang="en-US" sz="1000" dirty="0" smtClean="0">
                <a:solidFill>
                  <a:prstClr val="black"/>
                </a:solidFill>
              </a:rPr>
              <a:t>GAPDH mRNA transcript level.</a:t>
            </a:r>
            <a:endParaRPr lang="en-GB" altLang="en-US" sz="1000" dirty="0">
              <a:solidFill>
                <a:prstClr val="black"/>
              </a:solidFill>
            </a:endParaRPr>
          </a:p>
        </p:txBody>
      </p:sp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5911173"/>
              </p:ext>
            </p:extLst>
          </p:nvPr>
        </p:nvGraphicFramePr>
        <p:xfrm>
          <a:off x="1673890" y="476672"/>
          <a:ext cx="6930558" cy="48245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8905210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blank">
  <a:themeElements>
    <a:clrScheme name="Roslin Colours 1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6FB34B"/>
      </a:accent1>
      <a:accent2>
        <a:srgbClr val="E4650F"/>
      </a:accent2>
      <a:accent3>
        <a:srgbClr val="67BDE6"/>
      </a:accent3>
      <a:accent4>
        <a:srgbClr val="CE3286"/>
      </a:accent4>
      <a:accent5>
        <a:srgbClr val="FFFF00"/>
      </a:accent5>
      <a:accent6>
        <a:srgbClr val="FF0000"/>
      </a:accent6>
      <a:hlink>
        <a:srgbClr val="E4650F"/>
      </a:hlink>
      <a:folHlink>
        <a:srgbClr val="E4650F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6</TotalTime>
  <Words>24</Words>
  <Application>Microsoft Office PowerPoint</Application>
  <PresentationFormat>Affichage à l'écran 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2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blank</vt:lpstr>
      <vt:lpstr>Office Theme</vt:lpstr>
      <vt:lpstr>Présentation PowerPoint</vt:lpstr>
    </vt:vector>
  </TitlesOfParts>
  <Company>University of Edinburgh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IT-ALI Tahar</dc:creator>
  <cp:lastModifiedBy>ecoulamy</cp:lastModifiedBy>
  <cp:revision>4</cp:revision>
  <dcterms:created xsi:type="dcterms:W3CDTF">2014-02-19T16:54:19Z</dcterms:created>
  <dcterms:modified xsi:type="dcterms:W3CDTF">2014-04-07T14:07:41Z</dcterms:modified>
</cp:coreProperties>
</file>